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295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460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628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384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126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375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102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17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680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032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66126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A3291-19CC-4977-AE69-486F01E25634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742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364238" y="587543"/>
            <a:ext cx="7127495" cy="5143558"/>
            <a:chOff x="1411200" y="767849"/>
            <a:chExt cx="6023199" cy="4049896"/>
          </a:xfrm>
        </p:grpSpPr>
        <p:sp>
          <p:nvSpPr>
            <p:cNvPr id="10" name="TextBox 34"/>
            <p:cNvSpPr txBox="1">
              <a:spLocks noChangeArrowheads="1"/>
            </p:cNvSpPr>
            <p:nvPr/>
          </p:nvSpPr>
          <p:spPr bwMode="auto">
            <a:xfrm>
              <a:off x="2362852" y="1733267"/>
              <a:ext cx="756000" cy="2160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463 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IFA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1411200" y="767849"/>
              <a:ext cx="6023199" cy="4049896"/>
              <a:chOff x="1411200" y="767849"/>
              <a:chExt cx="6023199" cy="4049896"/>
            </a:xfrm>
          </p:grpSpPr>
          <p:sp>
            <p:nvSpPr>
              <p:cNvPr id="31" name="Text Box 19"/>
              <p:cNvSpPr txBox="1">
                <a:spLocks noChangeArrowheads="1"/>
              </p:cNvSpPr>
              <p:nvPr/>
            </p:nvSpPr>
            <p:spPr bwMode="auto">
              <a:xfrm>
                <a:off x="1412344" y="2844000"/>
                <a:ext cx="1183120" cy="71910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3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eterm births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pregnancy loss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6 lost to follow-up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lasma not obtained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7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issed visit</a:t>
                </a:r>
              </a:p>
            </p:txBody>
          </p:sp>
          <p:sp>
            <p:nvSpPr>
              <p:cNvPr id="9" name="TextBox 33"/>
              <p:cNvSpPr txBox="1">
                <a:spLocks noChangeArrowheads="1"/>
              </p:cNvSpPr>
              <p:nvPr/>
            </p:nvSpPr>
            <p:spPr bwMode="auto">
              <a:xfrm>
                <a:off x="6336399" y="1748458"/>
                <a:ext cx="756000" cy="216000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462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LNS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35"/>
              <p:cNvSpPr txBox="1">
                <a:spLocks noChangeArrowheads="1"/>
              </p:cNvSpPr>
              <p:nvPr/>
            </p:nvSpPr>
            <p:spPr bwMode="auto">
              <a:xfrm>
                <a:off x="4355129" y="1754906"/>
                <a:ext cx="756000" cy="216000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466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MMN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31"/>
              <p:cNvSpPr txBox="1"/>
              <p:nvPr/>
            </p:nvSpPr>
            <p:spPr>
              <a:xfrm>
                <a:off x="2020852" y="2356950"/>
                <a:ext cx="1440000" cy="4536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Enrollment:</a:t>
                </a: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Plasma fatty acids: n=103</a:t>
                </a: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Plasma lipids: n=457</a:t>
                </a:r>
                <a:endParaRPr lang="en-US" sz="9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 Box 2"/>
              <p:cNvSpPr txBox="1">
                <a:spLocks noChangeArrowheads="1"/>
              </p:cNvSpPr>
              <p:nvPr/>
            </p:nvSpPr>
            <p:spPr bwMode="auto">
              <a:xfrm>
                <a:off x="1411200" y="2018101"/>
                <a:ext cx="1191084" cy="219916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en-US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ssing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lasma</a:t>
                </a:r>
                <a:r>
                  <a:rPr kumimoji="0" lang="en-US" altLang="en-US" sz="9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ipids</a:t>
                </a:r>
              </a:p>
            </p:txBody>
          </p:sp>
          <p:sp>
            <p:nvSpPr>
              <p:cNvPr id="32" name="Text Box 15"/>
              <p:cNvSpPr txBox="1">
                <a:spLocks noChangeArrowheads="1"/>
              </p:cNvSpPr>
              <p:nvPr/>
            </p:nvSpPr>
            <p:spPr bwMode="auto">
              <a:xfrm>
                <a:off x="3310172" y="2018101"/>
                <a:ext cx="1191600" cy="21960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900" dirty="0" smtClean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en-US" sz="900" dirty="0" smtClean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missing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plasma lipids</a:t>
                </a:r>
              </a:p>
            </p:txBody>
          </p:sp>
          <p:sp>
            <p:nvSpPr>
              <p:cNvPr id="35" name="Text Box 17"/>
              <p:cNvSpPr txBox="1">
                <a:spLocks noChangeArrowheads="1"/>
              </p:cNvSpPr>
              <p:nvPr/>
            </p:nvSpPr>
            <p:spPr bwMode="auto">
              <a:xfrm>
                <a:off x="3310172" y="2844001"/>
                <a:ext cx="1239327" cy="71910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24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preterm births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6 pregnancy loss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37 lost to follow-up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5 plasma not</a:t>
                </a:r>
                <a:r>
                  <a:rPr kumimoji="0" lang="en-US" altLang="en-US" sz="9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obtained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 missed visit</a:t>
                </a:r>
              </a:p>
            </p:txBody>
          </p:sp>
          <p:sp>
            <p:nvSpPr>
              <p:cNvPr id="36" name="Text Box 16"/>
              <p:cNvSpPr txBox="1">
                <a:spLocks noChangeArrowheads="1"/>
              </p:cNvSpPr>
              <p:nvPr/>
            </p:nvSpPr>
            <p:spPr bwMode="auto">
              <a:xfrm>
                <a:off x="5285702" y="2019600"/>
                <a:ext cx="1191600" cy="21960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 </a:t>
                </a:r>
                <a:r>
                  <a:rPr lang="en-US" altLang="en-US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ssing</a:t>
                </a:r>
                <a:r>
                  <a:rPr kumimoji="0" lang="en-US" altLang="en-US" sz="9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lasma lipids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 Box 18"/>
              <p:cNvSpPr txBox="1">
                <a:spLocks noChangeArrowheads="1"/>
              </p:cNvSpPr>
              <p:nvPr/>
            </p:nvSpPr>
            <p:spPr bwMode="auto">
              <a:xfrm>
                <a:off x="5285701" y="2844000"/>
                <a:ext cx="1191599" cy="727405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21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preterm births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8 pregnancy loss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26 lost to follow-up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r>
                  <a:rPr lang="en-US" altLang="en-US" sz="900" dirty="0" smtClean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plasma not obtained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36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missed visit</a:t>
                </a:r>
              </a:p>
            </p:txBody>
          </p:sp>
          <p:sp>
            <p:nvSpPr>
              <p:cNvPr id="42" name="Text Box 26"/>
              <p:cNvSpPr txBox="1">
                <a:spLocks noChangeArrowheads="1"/>
              </p:cNvSpPr>
              <p:nvPr/>
            </p:nvSpPr>
            <p:spPr bwMode="auto">
              <a:xfrm>
                <a:off x="2019600" y="3587174"/>
                <a:ext cx="1440000" cy="453600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36 wk gestation: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sma fatty acids: n=103 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sma lipids: n=352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3" name="Straight Arrow Connector 22"/>
              <p:cNvCxnSpPr>
                <a:stCxn id="10" idx="2"/>
                <a:endCxn id="17" idx="0"/>
              </p:cNvCxnSpPr>
              <p:nvPr/>
            </p:nvCxnSpPr>
            <p:spPr>
              <a:xfrm>
                <a:off x="2740852" y="1949267"/>
                <a:ext cx="0" cy="407683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Arrow Connector 32"/>
              <p:cNvCxnSpPr>
                <a:stCxn id="17" idx="2"/>
                <a:endCxn id="42" idx="0"/>
              </p:cNvCxnSpPr>
              <p:nvPr/>
            </p:nvCxnSpPr>
            <p:spPr>
              <a:xfrm flipH="1">
                <a:off x="2739600" y="2810550"/>
                <a:ext cx="1252" cy="77662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>
                <a:stCxn id="11" idx="2"/>
                <a:endCxn id="122" idx="0"/>
              </p:cNvCxnSpPr>
              <p:nvPr/>
            </p:nvCxnSpPr>
            <p:spPr>
              <a:xfrm flipH="1">
                <a:off x="4730100" y="1970906"/>
                <a:ext cx="3029" cy="38709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Arrow Connector 46"/>
              <p:cNvCxnSpPr>
                <a:stCxn id="122" idx="2"/>
                <a:endCxn id="133" idx="0"/>
              </p:cNvCxnSpPr>
              <p:nvPr/>
            </p:nvCxnSpPr>
            <p:spPr>
              <a:xfrm>
                <a:off x="4730100" y="2812337"/>
                <a:ext cx="2070" cy="77483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>
                <a:stCxn id="9" idx="2"/>
                <a:endCxn id="121" idx="0"/>
              </p:cNvCxnSpPr>
              <p:nvPr/>
            </p:nvCxnSpPr>
            <p:spPr>
              <a:xfrm>
                <a:off x="6714399" y="1964458"/>
                <a:ext cx="0" cy="393542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>
                <a:stCxn id="121" idx="2"/>
                <a:endCxn id="132" idx="0"/>
              </p:cNvCxnSpPr>
              <p:nvPr/>
            </p:nvCxnSpPr>
            <p:spPr>
              <a:xfrm flipH="1">
                <a:off x="6711301" y="2812337"/>
                <a:ext cx="3098" cy="77483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Arrow Connector 60"/>
              <p:cNvCxnSpPr/>
              <p:nvPr/>
            </p:nvCxnSpPr>
            <p:spPr>
              <a:xfrm flipV="1">
                <a:off x="4501771" y="2138266"/>
                <a:ext cx="23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Arrow Connector 62"/>
              <p:cNvCxnSpPr/>
              <p:nvPr/>
            </p:nvCxnSpPr>
            <p:spPr>
              <a:xfrm>
                <a:off x="6477301" y="2139675"/>
                <a:ext cx="23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Elbow Connector 70"/>
              <p:cNvCxnSpPr/>
              <p:nvPr/>
            </p:nvCxnSpPr>
            <p:spPr>
              <a:xfrm>
                <a:off x="4723922" y="1563234"/>
                <a:ext cx="1990477" cy="194749"/>
              </a:xfrm>
              <a:prstGeom prst="bentConnector2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Elbow Connector 72"/>
              <p:cNvCxnSpPr>
                <a:endCxn id="10" idx="0"/>
              </p:cNvCxnSpPr>
              <p:nvPr/>
            </p:nvCxnSpPr>
            <p:spPr>
              <a:xfrm rot="10800000" flipV="1">
                <a:off x="2740852" y="1558343"/>
                <a:ext cx="2307666" cy="174923"/>
              </a:xfrm>
              <a:prstGeom prst="bentConnector2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6"/>
              <p:cNvSpPr txBox="1">
                <a:spLocks noChangeArrowheads="1"/>
              </p:cNvSpPr>
              <p:nvPr/>
            </p:nvSpPr>
            <p:spPr bwMode="auto">
              <a:xfrm>
                <a:off x="3624111" y="767849"/>
                <a:ext cx="2215166" cy="322862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,391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women enrolled and </a:t>
                </a: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selected for analysis of plasma lipids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TextBox 31"/>
              <p:cNvSpPr txBox="1"/>
              <p:nvPr/>
            </p:nvSpPr>
            <p:spPr>
              <a:xfrm>
                <a:off x="5994399" y="2358000"/>
                <a:ext cx="1440000" cy="45433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Enrollment:</a:t>
                </a: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Plasma fatty acids: n=106</a:t>
                </a: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Plasma lipids: n=453</a:t>
                </a:r>
                <a:endParaRPr lang="en-US" sz="9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TextBox 31"/>
              <p:cNvSpPr txBox="1"/>
              <p:nvPr/>
            </p:nvSpPr>
            <p:spPr>
              <a:xfrm>
                <a:off x="4010100" y="2358000"/>
                <a:ext cx="1440000" cy="45433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Enrollment:</a:t>
                </a: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Plasma fatty acids: n=106</a:t>
                </a: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Plasma lipids: n=463</a:t>
                </a:r>
                <a:endParaRPr lang="en-US" sz="9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Text Box 26"/>
              <p:cNvSpPr txBox="1">
                <a:spLocks noChangeArrowheads="1"/>
              </p:cNvSpPr>
              <p:nvPr/>
            </p:nvSpPr>
            <p:spPr bwMode="auto">
              <a:xfrm>
                <a:off x="5991301" y="3587175"/>
                <a:ext cx="1440000" cy="453600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36 wk gestation: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sma fatty acids: n=106 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sma lipids: n=352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Text Box 26"/>
              <p:cNvSpPr txBox="1">
                <a:spLocks noChangeArrowheads="1"/>
              </p:cNvSpPr>
              <p:nvPr/>
            </p:nvSpPr>
            <p:spPr bwMode="auto">
              <a:xfrm>
                <a:off x="4012170" y="3587175"/>
                <a:ext cx="1440000" cy="453600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36 wk gestation: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sma fatty acids: n=106 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sma lipids: n=363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4" name="Straight Arrow Connector 133"/>
              <p:cNvCxnSpPr>
                <a:stCxn id="42" idx="2"/>
                <a:endCxn id="138" idx="0"/>
              </p:cNvCxnSpPr>
              <p:nvPr/>
            </p:nvCxnSpPr>
            <p:spPr>
              <a:xfrm>
                <a:off x="2739600" y="4040774"/>
                <a:ext cx="3754" cy="41000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Arrow Connector 134"/>
              <p:cNvCxnSpPr>
                <a:stCxn id="132" idx="2"/>
                <a:endCxn id="141" idx="0"/>
              </p:cNvCxnSpPr>
              <p:nvPr/>
            </p:nvCxnSpPr>
            <p:spPr>
              <a:xfrm>
                <a:off x="6711301" y="4040775"/>
                <a:ext cx="0" cy="40882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Straight Arrow Connector 135"/>
              <p:cNvCxnSpPr>
                <a:stCxn id="133" idx="2"/>
                <a:endCxn id="142" idx="0"/>
              </p:cNvCxnSpPr>
              <p:nvPr/>
            </p:nvCxnSpPr>
            <p:spPr>
              <a:xfrm>
                <a:off x="4732170" y="4040775"/>
                <a:ext cx="4455" cy="410003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" name="Text Box 26"/>
              <p:cNvSpPr txBox="1">
                <a:spLocks noChangeArrowheads="1"/>
              </p:cNvSpPr>
              <p:nvPr/>
            </p:nvSpPr>
            <p:spPr bwMode="auto">
              <a:xfrm>
                <a:off x="2023354" y="4450778"/>
                <a:ext cx="1440000" cy="366967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6 mo postpartum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: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east milk fatty acids: n=103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Text Box 26"/>
              <p:cNvSpPr txBox="1">
                <a:spLocks noChangeArrowheads="1"/>
              </p:cNvSpPr>
              <p:nvPr/>
            </p:nvSpPr>
            <p:spPr bwMode="auto">
              <a:xfrm>
                <a:off x="5991301" y="4449600"/>
                <a:ext cx="1440000" cy="367200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6 mo postpartum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: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east milk fatty acids: n=106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Text Box 26"/>
              <p:cNvSpPr txBox="1">
                <a:spLocks noChangeArrowheads="1"/>
              </p:cNvSpPr>
              <p:nvPr/>
            </p:nvSpPr>
            <p:spPr bwMode="auto">
              <a:xfrm>
                <a:off x="4016625" y="4450778"/>
                <a:ext cx="1440000" cy="366967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6 mo postpartum</a:t>
                </a: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:</a:t>
                </a: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east milk fatty acids: n=106</a:t>
                </a:r>
                <a:endPara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0" name="Straight Arrow Connector 59"/>
              <p:cNvCxnSpPr>
                <a:stCxn id="54" idx="2"/>
                <a:endCxn id="11" idx="0"/>
              </p:cNvCxnSpPr>
              <p:nvPr/>
            </p:nvCxnSpPr>
            <p:spPr>
              <a:xfrm>
                <a:off x="4731694" y="1090711"/>
                <a:ext cx="1435" cy="66419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Straight Arrow Connector 124"/>
              <p:cNvCxnSpPr/>
              <p:nvPr/>
            </p:nvCxnSpPr>
            <p:spPr>
              <a:xfrm>
                <a:off x="2505311" y="3196725"/>
                <a:ext cx="23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Arrow Connector 147"/>
              <p:cNvCxnSpPr/>
              <p:nvPr/>
            </p:nvCxnSpPr>
            <p:spPr>
              <a:xfrm>
                <a:off x="6477299" y="3195150"/>
                <a:ext cx="23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Straight Arrow Connector 154"/>
              <p:cNvCxnSpPr/>
              <p:nvPr/>
            </p:nvCxnSpPr>
            <p:spPr>
              <a:xfrm>
                <a:off x="4498418" y="3196710"/>
                <a:ext cx="23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Arrow Connector 159"/>
              <p:cNvCxnSpPr/>
              <p:nvPr/>
            </p:nvCxnSpPr>
            <p:spPr>
              <a:xfrm>
                <a:off x="2513963" y="2138266"/>
                <a:ext cx="23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Arrow Connector 54"/>
              <p:cNvCxnSpPr/>
              <p:nvPr/>
            </p:nvCxnSpPr>
            <p:spPr>
              <a:xfrm>
                <a:off x="3513676" y="1301750"/>
                <a:ext cx="1218267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Rectangle 55"/>
              <p:cNvSpPr/>
              <p:nvPr/>
            </p:nvSpPr>
            <p:spPr>
              <a:xfrm>
                <a:off x="2007008" y="1126806"/>
                <a:ext cx="1506669" cy="290802"/>
              </a:xfrm>
              <a:prstGeom prst="rect">
                <a:avLst/>
              </a:prstGeom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9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,076 not selected for fatty acid analysis subsample</a:t>
                </a:r>
                <a:endParaRPr lang="en-US" sz="9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629272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9</Words>
  <Application>Microsoft Office PowerPoint</Application>
  <PresentationFormat>Widescreen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